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428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FE9488-F092-F4C6-13F9-8E7D75AC2E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46C873B-1A99-8F3E-3697-EB8287D460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C43F52-784D-21E8-A980-2297C615D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37D44C-67DB-0E1E-F454-FDA9250FC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A559A6-33DD-04CD-AF6C-E45D001C6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846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C831C9-E8D9-B534-128E-CD1AD7844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FB615D6-3F18-2EEB-69F3-978B2759A7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A0C74B-783A-ED6E-AC8F-CB23BFC12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0C38EF-F4A8-4463-6AE3-58978172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15CA41-A174-773B-67BE-96F8A3B27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16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F4D218A-D563-CCAE-FCD3-6903D5F94D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D26A9BB-A82C-9681-28A8-5657A0AFF1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7D4CB8-82AE-B2DD-69EA-8BA34C51A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B85F09-C076-D651-B934-33908C8A5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DE9642-2C2E-3292-E330-E32FB4661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38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FAD8A5-7CBF-2388-6602-065E2C336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0267EAC-D2BE-8B4D-DA68-0A7C42D991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7CDA44-80CC-082D-D738-ED3722DE5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7FDB84-6AD0-E714-448C-852F9A16D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44D723-2796-5A03-3C15-3293BE7C7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52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2F2D18-2F21-4F89-0C21-84E414EB92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708E737-30D3-DD86-9C8B-30CC45505B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71F154-FB21-27D2-3ACD-0EB53089A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2D2E41-9847-CE68-1B07-77CE94CAE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68A066-C9ED-C847-C8B6-6240062FD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98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A06C78-975B-449F-62D6-4CE319A33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98809AA-3360-BA70-6B61-69D7BA9B47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2C54D3-A6E4-BA5F-22E2-79A4667F65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6B7A6B-A203-DD83-4966-CB53F3193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DF59EF-82BA-A7C7-D123-EC8F82FD9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86BBA56-CE34-FEC5-79FC-41F40998C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50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F7BA14-A559-6805-FA8E-05D648E6A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4015B7-16F3-CB1F-76E7-42EF13C03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932FA86-D1E1-49F2-A93A-9A71C025B9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6A6D556-95EC-F051-9DEF-392EA2CD18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92D6546-0E15-8E24-0AFC-23CDF45AAA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67624E8-B191-5017-C94D-4696671FC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8C69D77-9EB1-BF41-94E9-03B1A3E20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0524037-F15F-5816-3990-3FCF0FC3C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3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EC5F1B-CA20-4C82-0CEE-E78D10E0D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095566-ABB2-991E-AB89-082863EDD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D5F9A8A-516F-E8A6-1F53-FA7C7FD97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E515B17-A574-B9ED-14B2-9779EEA75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529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FB2D184-4524-E5A6-279B-E70905747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1E82B72-1338-899A-0BC2-F0E739AFB1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A9A7907-6246-65F9-4FD5-CA8328AB9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671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DEE255-42C1-99BE-7D08-6E1AD120C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CF0472-1756-150A-DB58-90158035A8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331BECC-BB83-3E95-F9BF-A4E816E2C7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910A182-68AE-3F64-1516-B402E9D9B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A89651-5ADB-C392-723D-BE0BDFAC2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0AD29B-76DE-915F-60A2-4896705B9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83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BB1D51-2335-3139-AFBC-FE4103B14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5350475-4E34-BFF6-8231-23B380A71F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8961AA4-5742-AEAD-9045-F3C7FE683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D84625-7B29-4E14-4BB6-648B153EB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9180BA-4EA0-9587-B39F-1C99A6BFA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7127FA-794D-02BA-6361-091341B4A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005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9090C85-4CC0-A518-6E3D-0AFD70EC0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8462F2-3A47-D7F2-F70F-56EF764CF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FDB8E4-A854-61F2-09B9-6242BCBDD9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22D33-F5B7-4831-9CB3-0FC1EE4383A7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1368F4-0A44-CFB7-DDDF-1739FA8F7D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E7F89A-0878-F657-19F5-D93688449F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1151B-D99B-4EEF-AB12-2C999FFBAE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572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78EEBBF-9B16-6A6A-F468-B1ABFD5710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6963854"/>
              </p:ext>
            </p:extLst>
          </p:nvPr>
        </p:nvGraphicFramePr>
        <p:xfrm>
          <a:off x="3036000" y="1860008"/>
          <a:ext cx="6120000" cy="1568992"/>
        </p:xfrm>
        <a:graphic>
          <a:graphicData uri="http://schemas.openxmlformats.org/drawingml/2006/table">
            <a:tbl>
              <a:tblPr/>
              <a:tblGrid>
                <a:gridCol w="1800000">
                  <a:extLst>
                    <a:ext uri="{9D8B030D-6E8A-4147-A177-3AD203B41FA5}">
                      <a16:colId xmlns:a16="http://schemas.microsoft.com/office/drawing/2014/main" val="2342437823"/>
                    </a:ext>
                  </a:extLst>
                </a:gridCol>
                <a:gridCol w="2160000">
                  <a:extLst>
                    <a:ext uri="{9D8B030D-6E8A-4147-A177-3AD203B41FA5}">
                      <a16:colId xmlns:a16="http://schemas.microsoft.com/office/drawing/2014/main" val="3934973302"/>
                    </a:ext>
                  </a:extLst>
                </a:gridCol>
                <a:gridCol w="2160000">
                  <a:extLst>
                    <a:ext uri="{9D8B030D-6E8A-4147-A177-3AD203B41FA5}">
                      <a16:colId xmlns:a16="http://schemas.microsoft.com/office/drawing/2014/main" val="2152227582"/>
                    </a:ext>
                  </a:extLst>
                </a:gridCol>
              </a:tblGrid>
              <a:tr h="3922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condary medical reg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umber of hospitals (%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umber of patients (%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2358944"/>
                  </a:ext>
                </a:extLst>
              </a:tr>
              <a:tr h="3922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galopoli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 (38.1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2 (58.3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0900089"/>
                  </a:ext>
                </a:extLst>
              </a:tr>
              <a:tr h="3922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ba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 (35.7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74 (36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510446"/>
                  </a:ext>
                </a:extLst>
              </a:tr>
              <a:tr h="3922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Rura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 (26.2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 (5.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6325278"/>
                  </a:ext>
                </a:extLst>
              </a:tr>
            </a:tbl>
          </a:graphicData>
        </a:graphic>
      </p:graphicFrame>
      <p:sp>
        <p:nvSpPr>
          <p:cNvPr id="4" name="タイトル 1">
            <a:extLst>
              <a:ext uri="{FF2B5EF4-FFF2-40B4-BE49-F238E27FC236}">
                <a16:creationId xmlns:a16="http://schemas.microsoft.com/office/drawing/2014/main" id="{5561BF74-78C2-D79F-8642-7DFEE9113752}"/>
              </a:ext>
            </a:extLst>
          </p:cNvPr>
          <p:cNvSpPr txBox="1">
            <a:spLocks/>
          </p:cNvSpPr>
          <p:nvPr/>
        </p:nvSpPr>
        <p:spPr>
          <a:xfrm>
            <a:off x="462474" y="4616"/>
            <a:ext cx="10800000" cy="540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Table S1. Details of secondary medical region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0359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47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恭章 瓜生</dc:creator>
  <cp:lastModifiedBy>恭章 瓜生</cp:lastModifiedBy>
  <cp:revision>15</cp:revision>
  <dcterms:created xsi:type="dcterms:W3CDTF">2024-09-08T23:50:22Z</dcterms:created>
  <dcterms:modified xsi:type="dcterms:W3CDTF">2024-11-27T02:48:50Z</dcterms:modified>
</cp:coreProperties>
</file>